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01" r:id="rId2"/>
    <p:sldId id="308" r:id="rId3"/>
    <p:sldId id="310" r:id="rId4"/>
  </p:sldIdLst>
  <p:sldSz cx="12192000" cy="12192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blogargon1@gmail.com" initials="p" lastIdx="1" clrIdx="0">
    <p:extLst>
      <p:ext uri="{19B8F6BF-5375-455C-9EA6-DF929625EA0E}">
        <p15:presenceInfo xmlns:p15="http://schemas.microsoft.com/office/powerpoint/2012/main" userId="ac67d1d8a74de6e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2CEE"/>
    <a:srgbClr val="FF4500"/>
    <a:srgbClr val="798234"/>
    <a:srgbClr val="EE7621"/>
    <a:srgbClr val="FFC125"/>
    <a:srgbClr val="548B54"/>
    <a:srgbClr val="EE9A00"/>
    <a:srgbClr val="FF40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55" autoAdjust="0"/>
    <p:restoredTop sz="83021" autoAdjust="0"/>
  </p:normalViewPr>
  <p:slideViewPr>
    <p:cSldViewPr snapToGrid="0">
      <p:cViewPr varScale="1">
        <p:scale>
          <a:sx n="54" d="100"/>
          <a:sy n="54" d="100"/>
        </p:scale>
        <p:origin x="29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8A79E3-CA4C-4595-93C6-15DBFD328F89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265882-0989-4F47-B466-95733F702F0B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045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95312"/>
            <a:ext cx="10363200" cy="424462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403623"/>
            <a:ext cx="9144000" cy="294357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887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963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49111"/>
            <a:ext cx="2628900" cy="10332156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49111"/>
            <a:ext cx="7734300" cy="10332156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4129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4468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039537"/>
            <a:ext cx="10515600" cy="5071532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159048"/>
            <a:ext cx="10515600" cy="2666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2034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245556"/>
            <a:ext cx="5181600" cy="7735712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245556"/>
            <a:ext cx="5181600" cy="7735712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2464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49114"/>
            <a:ext cx="10515600" cy="2356556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88734"/>
            <a:ext cx="5157787" cy="146473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453467"/>
            <a:ext cx="5157787" cy="6550379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88734"/>
            <a:ext cx="5183188" cy="146473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453467"/>
            <a:ext cx="5183188" cy="6550379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525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7657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611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2800"/>
            <a:ext cx="3932237" cy="28448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55425"/>
            <a:ext cx="6172200" cy="866422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57600"/>
            <a:ext cx="3932237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321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2800"/>
            <a:ext cx="3932237" cy="28448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55425"/>
            <a:ext cx="6172200" cy="866422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57600"/>
            <a:ext cx="3932237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8140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49114"/>
            <a:ext cx="105156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245556"/>
            <a:ext cx="105156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300181"/>
            <a:ext cx="27432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575DC-E189-4EE0-BFC5-F8E683BA1EFF}" type="datetimeFigureOut">
              <a:rPr lang="en-GB" smtClean="0"/>
              <a:t>14/04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300181"/>
            <a:ext cx="41148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300181"/>
            <a:ext cx="27432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E15E8-1BBB-4E98-8602-E4E465311E5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427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>
            <a:extLst>
              <a:ext uri="{FF2B5EF4-FFF2-40B4-BE49-F238E27FC236}">
                <a16:creationId xmlns:a16="http://schemas.microsoft.com/office/drawing/2014/main" id="{6EBBC80A-62AE-EE21-6192-B8B4C5B5E3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569" y="2079813"/>
            <a:ext cx="10098796" cy="5699497"/>
          </a:xfrm>
          <a:prstGeom prst="rect">
            <a:avLst/>
          </a:prstGeom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id="{926B5C8C-0105-6AFF-3A19-C7C58DE1F585}"/>
              </a:ext>
            </a:extLst>
          </p:cNvPr>
          <p:cNvSpPr txBox="1"/>
          <p:nvPr/>
        </p:nvSpPr>
        <p:spPr>
          <a:xfrm>
            <a:off x="546721" y="400445"/>
            <a:ext cx="1105007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1. PCR optimization</a:t>
            </a:r>
            <a:r>
              <a:rPr lang="en-US" dirty="0"/>
              <a:t>. Different conditions tested in a single sample to search for optimal reaction. The optimal conditions were primer pair APOE_III with 10% DMSO and buffer 2. The PCR products were examined by automated capillary electrophoresis using the </a:t>
            </a:r>
            <a:r>
              <a:rPr lang="en-US" dirty="0" err="1"/>
              <a:t>LabChip</a:t>
            </a:r>
            <a:r>
              <a:rPr lang="en-US" dirty="0"/>
              <a:t> GX Touch Nucleic Acid Analyzer (</a:t>
            </a:r>
            <a:r>
              <a:rPr lang="en-US" dirty="0" err="1"/>
              <a:t>Revvity</a:t>
            </a:r>
            <a:r>
              <a:rPr lang="en-US" dirty="0"/>
              <a:t>, CLS138162) and the DNA 12K Reagent Kit (</a:t>
            </a:r>
            <a:r>
              <a:rPr lang="en-US" dirty="0" err="1"/>
              <a:t>Revvity</a:t>
            </a:r>
            <a:r>
              <a:rPr lang="en-US" dirty="0"/>
              <a:t>, 760569). </a:t>
            </a:r>
          </a:p>
        </p:txBody>
      </p:sp>
    </p:spTree>
    <p:extLst>
      <p:ext uri="{BB962C8B-B14F-4D97-AF65-F5344CB8AC3E}">
        <p14:creationId xmlns:p14="http://schemas.microsoft.com/office/powerpoint/2010/main" val="14258650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">
            <a:extLst>
              <a:ext uri="{FF2B5EF4-FFF2-40B4-BE49-F238E27FC236}">
                <a16:creationId xmlns:a16="http://schemas.microsoft.com/office/drawing/2014/main" id="{926B5C8C-0105-6AFF-3A19-C7C58DE1F585}"/>
              </a:ext>
            </a:extLst>
          </p:cNvPr>
          <p:cNvSpPr txBox="1"/>
          <p:nvPr/>
        </p:nvSpPr>
        <p:spPr>
          <a:xfrm>
            <a:off x="546721" y="400445"/>
            <a:ext cx="1105007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2. Variables explaining CSF APOE levels in </a:t>
            </a:r>
            <a:r>
              <a:rPr lang="en-US" b="1" dirty="0" err="1" smtClean="0"/>
              <a:t>Olink</a:t>
            </a:r>
            <a:r>
              <a:rPr lang="en-US" b="1" dirty="0" smtClean="0"/>
              <a:t> data. </a:t>
            </a:r>
            <a:r>
              <a:rPr lang="en-US" dirty="0" smtClean="0"/>
              <a:t>Introducing adjustment using the </a:t>
            </a:r>
            <a:r>
              <a:rPr lang="en-US" dirty="0" err="1" smtClean="0"/>
              <a:t>Somascan</a:t>
            </a:r>
            <a:r>
              <a:rPr lang="en-US" dirty="0" smtClean="0"/>
              <a:t> reference protein OPCML and the PC2 substantially improve the signal-to-noise  ratio.</a:t>
            </a:r>
            <a:endParaRPr lang="en-US" dirty="0"/>
          </a:p>
        </p:txBody>
      </p:sp>
      <p:grpSp>
        <p:nvGrpSpPr>
          <p:cNvPr id="10" name="Grupo 9"/>
          <p:cNvGrpSpPr/>
          <p:nvPr/>
        </p:nvGrpSpPr>
        <p:grpSpPr>
          <a:xfrm>
            <a:off x="672227" y="1804742"/>
            <a:ext cx="10924567" cy="4267209"/>
            <a:chOff x="546721" y="1595712"/>
            <a:chExt cx="10924567" cy="4267209"/>
          </a:xfrm>
        </p:grpSpPr>
        <p:pic>
          <p:nvPicPr>
            <p:cNvPr id="8" name="Imagen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6721" y="1595712"/>
              <a:ext cx="6096012" cy="4267209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75276" y="1595712"/>
              <a:ext cx="6096012" cy="4267209"/>
            </a:xfrm>
            <a:prstGeom prst="rect">
              <a:avLst/>
            </a:prstGeom>
          </p:spPr>
        </p:pic>
      </p:grpSp>
      <p:sp>
        <p:nvSpPr>
          <p:cNvPr id="11" name="CuadroTexto 10"/>
          <p:cNvSpPr txBox="1"/>
          <p:nvPr/>
        </p:nvSpPr>
        <p:spPr>
          <a:xfrm>
            <a:off x="2445974" y="1420021"/>
            <a:ext cx="2548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og CSF APOE levels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6359873" y="1404632"/>
            <a:ext cx="4737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og </a:t>
            </a:r>
            <a:r>
              <a:rPr lang="en-GB" b="1" dirty="0">
                <a:latin typeface="Helvetica" panose="020B0604020202020204" pitchFamily="34" charset="0"/>
                <a:cs typeface="Helvetica" panose="020B0604020202020204" pitchFamily="34" charset="0"/>
              </a:rPr>
              <a:t>CSF APOE 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evels (</a:t>
            </a:r>
            <a:r>
              <a:rPr lang="en-GB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OPCML &amp; PC2)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6687892"/>
              </p:ext>
            </p:extLst>
          </p:nvPr>
        </p:nvGraphicFramePr>
        <p:xfrm>
          <a:off x="1057406" y="7202621"/>
          <a:ext cx="4377205" cy="13435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94301">
                  <a:extLst>
                    <a:ext uri="{9D8B030D-6E8A-4147-A177-3AD203B41FA5}">
                      <a16:colId xmlns:a16="http://schemas.microsoft.com/office/drawing/2014/main" val="3757806556"/>
                    </a:ext>
                  </a:extLst>
                </a:gridCol>
                <a:gridCol w="820726">
                  <a:extLst>
                    <a:ext uri="{9D8B030D-6E8A-4147-A177-3AD203B41FA5}">
                      <a16:colId xmlns:a16="http://schemas.microsoft.com/office/drawing/2014/main" val="3880110020"/>
                    </a:ext>
                  </a:extLst>
                </a:gridCol>
                <a:gridCol w="820726">
                  <a:extLst>
                    <a:ext uri="{9D8B030D-6E8A-4147-A177-3AD203B41FA5}">
                      <a16:colId xmlns:a16="http://schemas.microsoft.com/office/drawing/2014/main" val="4271468887"/>
                    </a:ext>
                  </a:extLst>
                </a:gridCol>
                <a:gridCol w="820726">
                  <a:extLst>
                    <a:ext uri="{9D8B030D-6E8A-4147-A177-3AD203B41FA5}">
                      <a16:colId xmlns:a16="http://schemas.microsoft.com/office/drawing/2014/main" val="793391466"/>
                    </a:ext>
                  </a:extLst>
                </a:gridCol>
                <a:gridCol w="820726">
                  <a:extLst>
                    <a:ext uri="{9D8B030D-6E8A-4147-A177-3AD203B41FA5}">
                      <a16:colId xmlns:a16="http://schemas.microsoft.com/office/drawing/2014/main" val="678363908"/>
                    </a:ext>
                  </a:extLst>
                </a:gridCol>
              </a:tblGrid>
              <a:tr h="335880">
                <a:tc>
                  <a:txBody>
                    <a:bodyPr/>
                    <a:lstStyle/>
                    <a:p>
                      <a:pPr algn="l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Estimat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Std</a:t>
                      </a:r>
                      <a:r>
                        <a:rPr lang="es-ES" sz="1200" b="1" u="none" strike="noStrike" dirty="0">
                          <a:effectLst/>
                        </a:rPr>
                        <a:t>. Error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t </a:t>
                      </a:r>
                      <a:r>
                        <a:rPr lang="es-ES" sz="1200" b="1" u="none" strike="noStrike" dirty="0" err="1">
                          <a:effectLst/>
                        </a:rPr>
                        <a:t>valu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Pr(&gt;|t|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71241498"/>
                  </a:ext>
                </a:extLst>
              </a:tr>
              <a:tr h="33588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(</a:t>
                      </a:r>
                      <a:r>
                        <a:rPr lang="es-ES" sz="1200" b="1" u="none" strike="noStrike" dirty="0" err="1">
                          <a:effectLst/>
                        </a:rPr>
                        <a:t>Intercept</a:t>
                      </a:r>
                      <a:r>
                        <a:rPr lang="es-ES" sz="1200" b="1" u="none" strike="noStrike" dirty="0">
                          <a:effectLst/>
                        </a:rPr>
                        <a:t>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6,27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262,05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0E+00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29482959"/>
                  </a:ext>
                </a:extLst>
              </a:tr>
              <a:tr h="33588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4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-0,69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3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-20,49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5,14E-68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10134009"/>
                  </a:ext>
                </a:extLst>
              </a:tr>
              <a:tr h="33588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2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14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6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2,34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1,99E-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82960386"/>
                  </a:ext>
                </a:extLst>
              </a:tr>
            </a:tbl>
          </a:graphicData>
        </a:graphic>
      </p:graphicFrame>
      <p:sp>
        <p:nvSpPr>
          <p:cNvPr id="14" name="CuadroTexto 13"/>
          <p:cNvSpPr txBox="1"/>
          <p:nvPr/>
        </p:nvSpPr>
        <p:spPr>
          <a:xfrm>
            <a:off x="1057406" y="6267954"/>
            <a:ext cx="325762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inear model results:</a:t>
            </a:r>
          </a:p>
          <a:p>
            <a:r>
              <a:rPr lang="en-GB" sz="14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POE levels ~ N_APOE4 + N_APOE2</a:t>
            </a:r>
          </a:p>
          <a:p>
            <a:r>
              <a:rPr lang="en-GB" sz="14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Rsq</a:t>
            </a:r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= 0.47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6" name="Tabla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8106052"/>
              </p:ext>
            </p:extLst>
          </p:nvPr>
        </p:nvGraphicFramePr>
        <p:xfrm>
          <a:off x="6260240" y="7364474"/>
          <a:ext cx="4914900" cy="1938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4668">
                  <a:extLst>
                    <a:ext uri="{9D8B030D-6E8A-4147-A177-3AD203B41FA5}">
                      <a16:colId xmlns:a16="http://schemas.microsoft.com/office/drawing/2014/main" val="2993026760"/>
                    </a:ext>
                  </a:extLst>
                </a:gridCol>
                <a:gridCol w="855058">
                  <a:extLst>
                    <a:ext uri="{9D8B030D-6E8A-4147-A177-3AD203B41FA5}">
                      <a16:colId xmlns:a16="http://schemas.microsoft.com/office/drawing/2014/main" val="1311029932"/>
                    </a:ext>
                  </a:extLst>
                </a:gridCol>
                <a:gridCol w="855058">
                  <a:extLst>
                    <a:ext uri="{9D8B030D-6E8A-4147-A177-3AD203B41FA5}">
                      <a16:colId xmlns:a16="http://schemas.microsoft.com/office/drawing/2014/main" val="4233934098"/>
                    </a:ext>
                  </a:extLst>
                </a:gridCol>
                <a:gridCol w="855058">
                  <a:extLst>
                    <a:ext uri="{9D8B030D-6E8A-4147-A177-3AD203B41FA5}">
                      <a16:colId xmlns:a16="http://schemas.microsoft.com/office/drawing/2014/main" val="4176421410"/>
                    </a:ext>
                  </a:extLst>
                </a:gridCol>
                <a:gridCol w="855058">
                  <a:extLst>
                    <a:ext uri="{9D8B030D-6E8A-4147-A177-3AD203B41FA5}">
                      <a16:colId xmlns:a16="http://schemas.microsoft.com/office/drawing/2014/main" val="1252494814"/>
                    </a:ext>
                  </a:extLst>
                </a:gridCol>
              </a:tblGrid>
              <a:tr h="323135">
                <a:tc>
                  <a:txBody>
                    <a:bodyPr/>
                    <a:lstStyle/>
                    <a:p>
                      <a:pPr algn="l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Estimat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>
                          <a:effectLst/>
                        </a:rPr>
                        <a:t>Std. Error</a:t>
                      </a:r>
                      <a:endParaRPr lang="es-E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>
                          <a:effectLst/>
                        </a:rPr>
                        <a:t>t value</a:t>
                      </a:r>
                      <a:endParaRPr lang="es-E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Pr(&gt;|t|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62810211"/>
                  </a:ext>
                </a:extLst>
              </a:tr>
              <a:tr h="323135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(</a:t>
                      </a:r>
                      <a:r>
                        <a:rPr lang="es-ES" sz="1200" b="1" u="none" strike="noStrike" dirty="0" err="1">
                          <a:effectLst/>
                        </a:rPr>
                        <a:t>Intercept</a:t>
                      </a:r>
                      <a:r>
                        <a:rPr lang="es-ES" sz="1200" b="1" u="none" strike="noStrike" dirty="0">
                          <a:effectLst/>
                        </a:rPr>
                        <a:t>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6,30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1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455,55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0E+00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66284010"/>
                  </a:ext>
                </a:extLst>
              </a:tr>
              <a:tr h="323135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4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0,71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36,5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5,19E-140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58448487"/>
                  </a:ext>
                </a:extLst>
              </a:tr>
              <a:tr h="323135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2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8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3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2,3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2,07E-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74845915"/>
                  </a:ext>
                </a:extLst>
              </a:tr>
              <a:tr h="323135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OBCAM_seq.15622.13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28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24,36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1,24E-85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63789942"/>
                  </a:ext>
                </a:extLst>
              </a:tr>
              <a:tr h="323135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Somalogic_PC.2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0,06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0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13,23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3,02E-34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26283031"/>
                  </a:ext>
                </a:extLst>
              </a:tr>
            </a:tbl>
          </a:graphicData>
        </a:graphic>
      </p:graphicFrame>
      <p:sp>
        <p:nvSpPr>
          <p:cNvPr id="18" name="CuadroTexto 17"/>
          <p:cNvSpPr txBox="1"/>
          <p:nvPr/>
        </p:nvSpPr>
        <p:spPr>
          <a:xfrm>
            <a:off x="6260240" y="6226072"/>
            <a:ext cx="58174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inear model results:</a:t>
            </a:r>
          </a:p>
          <a:p>
            <a:r>
              <a:rPr lang="en-GB" sz="14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POE levels ~ N_APOE4 + N_APOE2 + OBCAM + Somascan_PC2</a:t>
            </a:r>
          </a:p>
          <a:p>
            <a:r>
              <a:rPr lang="en-GB" sz="14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Rsq</a:t>
            </a:r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= 0.83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896735"/>
              </p:ext>
            </p:extLst>
          </p:nvPr>
        </p:nvGraphicFramePr>
        <p:xfrm>
          <a:off x="1273392" y="9676811"/>
          <a:ext cx="4227390" cy="1337310"/>
        </p:xfrm>
        <a:graphic>
          <a:graphicData uri="http://schemas.openxmlformats.org/drawingml/2006/table">
            <a:tbl>
              <a:tblPr/>
              <a:tblGrid>
                <a:gridCol w="3361713">
                  <a:extLst>
                    <a:ext uri="{9D8B030D-6E8A-4147-A177-3AD203B41FA5}">
                      <a16:colId xmlns:a16="http://schemas.microsoft.com/office/drawing/2014/main" val="881012001"/>
                    </a:ext>
                  </a:extLst>
                </a:gridCol>
                <a:gridCol w="865677">
                  <a:extLst>
                    <a:ext uri="{9D8B030D-6E8A-4147-A177-3AD203B41FA5}">
                      <a16:colId xmlns:a16="http://schemas.microsoft.com/office/drawing/2014/main" val="91572547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variates</a:t>
                      </a:r>
                      <a:r>
                        <a:rPr lang="es-E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cluded</a:t>
                      </a:r>
                      <a:endParaRPr lang="es-E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jRsq</a:t>
                      </a:r>
                      <a:endParaRPr lang="es-E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4903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E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2619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 + PC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E7D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04342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E4 + APOE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DEB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476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 + PC2 + APOE4 + APOE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68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82595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 + PC2 + APOE4 + APOE2 + age + se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68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66423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79220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5">
            <a:extLst>
              <a:ext uri="{FF2B5EF4-FFF2-40B4-BE49-F238E27FC236}">
                <a16:creationId xmlns:a16="http://schemas.microsoft.com/office/drawing/2014/main" id="{926B5C8C-0105-6AFF-3A19-C7C58DE1F585}"/>
              </a:ext>
            </a:extLst>
          </p:cNvPr>
          <p:cNvSpPr txBox="1"/>
          <p:nvPr/>
        </p:nvSpPr>
        <p:spPr>
          <a:xfrm>
            <a:off x="546721" y="400445"/>
            <a:ext cx="1105007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</a:t>
            </a:r>
            <a:r>
              <a:rPr lang="en-US" b="1" dirty="0"/>
              <a:t>3</a:t>
            </a:r>
            <a:r>
              <a:rPr lang="en-US" b="1" dirty="0" smtClean="0"/>
              <a:t>. Variables explaining CSF APOE levels in </a:t>
            </a:r>
            <a:r>
              <a:rPr lang="en-US" b="1" dirty="0" err="1" smtClean="0"/>
              <a:t>Lumipulse</a:t>
            </a:r>
            <a:r>
              <a:rPr lang="en-US" b="1" dirty="0" smtClean="0"/>
              <a:t> data. </a:t>
            </a:r>
            <a:r>
              <a:rPr lang="en-US" dirty="0"/>
              <a:t>Introducing adjustment using the </a:t>
            </a:r>
            <a:r>
              <a:rPr lang="en-US" dirty="0" err="1"/>
              <a:t>Somascan</a:t>
            </a:r>
            <a:r>
              <a:rPr lang="en-US" dirty="0"/>
              <a:t> reference protein OPCML and the PC2 substantially improve the signal-to-noise  ratio.</a:t>
            </a:r>
            <a:r>
              <a:rPr lang="en-US" b="1" dirty="0" smtClean="0"/>
              <a:t> </a:t>
            </a:r>
            <a:endParaRPr lang="en-US" dirty="0"/>
          </a:p>
        </p:txBody>
      </p:sp>
      <p:grpSp>
        <p:nvGrpSpPr>
          <p:cNvPr id="8" name="Grupo 7"/>
          <p:cNvGrpSpPr/>
          <p:nvPr/>
        </p:nvGrpSpPr>
        <p:grpSpPr>
          <a:xfrm>
            <a:off x="653137" y="1799761"/>
            <a:ext cx="10943657" cy="4267210"/>
            <a:chOff x="653137" y="1828789"/>
            <a:chExt cx="10943657" cy="4267210"/>
          </a:xfrm>
        </p:grpSpPr>
        <p:pic>
          <p:nvPicPr>
            <p:cNvPr id="6" name="Imagen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137" y="1828789"/>
              <a:ext cx="6096012" cy="4267209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00782" y="1828790"/>
              <a:ext cx="6096012" cy="4267209"/>
            </a:xfrm>
            <a:prstGeom prst="rect">
              <a:avLst/>
            </a:prstGeom>
          </p:spPr>
        </p:pic>
      </p:grpSp>
      <p:sp>
        <p:nvSpPr>
          <p:cNvPr id="9" name="CuadroTexto 8"/>
          <p:cNvSpPr txBox="1"/>
          <p:nvPr/>
        </p:nvSpPr>
        <p:spPr>
          <a:xfrm>
            <a:off x="2259105" y="1404632"/>
            <a:ext cx="2548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Helvetica" panose="020B0604020202020204" pitchFamily="34" charset="0"/>
                <a:cs typeface="Helvetica" panose="020B0604020202020204" pitchFamily="34" charset="0"/>
              </a:rPr>
              <a:t>Log CSF 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POE levels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6359873" y="1404632"/>
            <a:ext cx="4737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og </a:t>
            </a:r>
            <a:r>
              <a:rPr lang="en-GB" b="1" dirty="0">
                <a:latin typeface="Helvetica" panose="020B0604020202020204" pitchFamily="34" charset="0"/>
                <a:cs typeface="Helvetica" panose="020B0604020202020204" pitchFamily="34" charset="0"/>
              </a:rPr>
              <a:t>CSF APOE 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evels (</a:t>
            </a:r>
            <a:r>
              <a:rPr lang="en-GB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</a:t>
            </a:r>
            <a:r>
              <a:rPr lang="en-GB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OPCML &amp; PC2)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627399"/>
              </p:ext>
            </p:extLst>
          </p:nvPr>
        </p:nvGraphicFramePr>
        <p:xfrm>
          <a:off x="1057406" y="7207602"/>
          <a:ext cx="4357916" cy="13037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8616">
                  <a:extLst>
                    <a:ext uri="{9D8B030D-6E8A-4147-A177-3AD203B41FA5}">
                      <a16:colId xmlns:a16="http://schemas.microsoft.com/office/drawing/2014/main" val="702059297"/>
                    </a:ext>
                  </a:extLst>
                </a:gridCol>
                <a:gridCol w="777325">
                  <a:extLst>
                    <a:ext uri="{9D8B030D-6E8A-4147-A177-3AD203B41FA5}">
                      <a16:colId xmlns:a16="http://schemas.microsoft.com/office/drawing/2014/main" val="101433557"/>
                    </a:ext>
                  </a:extLst>
                </a:gridCol>
                <a:gridCol w="777325">
                  <a:extLst>
                    <a:ext uri="{9D8B030D-6E8A-4147-A177-3AD203B41FA5}">
                      <a16:colId xmlns:a16="http://schemas.microsoft.com/office/drawing/2014/main" val="232040312"/>
                    </a:ext>
                  </a:extLst>
                </a:gridCol>
                <a:gridCol w="777325">
                  <a:extLst>
                    <a:ext uri="{9D8B030D-6E8A-4147-A177-3AD203B41FA5}">
                      <a16:colId xmlns:a16="http://schemas.microsoft.com/office/drawing/2014/main" val="2466288567"/>
                    </a:ext>
                  </a:extLst>
                </a:gridCol>
                <a:gridCol w="777325">
                  <a:extLst>
                    <a:ext uri="{9D8B030D-6E8A-4147-A177-3AD203B41FA5}">
                      <a16:colId xmlns:a16="http://schemas.microsoft.com/office/drawing/2014/main" val="3967456225"/>
                    </a:ext>
                  </a:extLst>
                </a:gridCol>
              </a:tblGrid>
              <a:tr h="325942">
                <a:tc>
                  <a:txBody>
                    <a:bodyPr/>
                    <a:lstStyle/>
                    <a:p>
                      <a:pPr algn="l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Estimat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Std</a:t>
                      </a:r>
                      <a:r>
                        <a:rPr lang="es-ES" sz="1200" b="1" u="none" strike="noStrike" dirty="0">
                          <a:effectLst/>
                        </a:rPr>
                        <a:t>. Error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t </a:t>
                      </a:r>
                      <a:r>
                        <a:rPr lang="es-ES" sz="1200" b="1" u="none" strike="noStrike" dirty="0" err="1">
                          <a:effectLst/>
                        </a:rPr>
                        <a:t>valu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Pr(&gt;|t|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46905641"/>
                  </a:ext>
                </a:extLst>
              </a:tr>
              <a:tr h="325942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(</a:t>
                      </a:r>
                      <a:r>
                        <a:rPr lang="es-ES" sz="1200" b="1" u="none" strike="noStrike" dirty="0" err="1">
                          <a:effectLst/>
                        </a:rPr>
                        <a:t>Intercept</a:t>
                      </a:r>
                      <a:r>
                        <a:rPr lang="es-ES" sz="1200" b="1" u="none" strike="noStrike" dirty="0">
                          <a:effectLst/>
                        </a:rPr>
                        <a:t>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81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46,26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4,93E-220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61136485"/>
                  </a:ext>
                </a:extLst>
              </a:tr>
              <a:tr h="325942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4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-0,6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25,48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3,87E-103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43048158"/>
                  </a:ext>
                </a:extLst>
              </a:tr>
              <a:tr h="325942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2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1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5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2,37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1,78E-0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00263971"/>
                  </a:ext>
                </a:extLst>
              </a:tr>
            </a:tbl>
          </a:graphicData>
        </a:graphic>
      </p:graphicFrame>
      <p:sp>
        <p:nvSpPr>
          <p:cNvPr id="12" name="CuadroTexto 11"/>
          <p:cNvSpPr txBox="1"/>
          <p:nvPr/>
        </p:nvSpPr>
        <p:spPr>
          <a:xfrm>
            <a:off x="1057406" y="6267954"/>
            <a:ext cx="325762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inear model results:</a:t>
            </a:r>
          </a:p>
          <a:p>
            <a:r>
              <a:rPr lang="en-GB" sz="14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POE levels ~ N_APOE4 + N_APOE2</a:t>
            </a:r>
          </a:p>
          <a:p>
            <a:r>
              <a:rPr lang="en-GB" sz="14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Rsq</a:t>
            </a:r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= 0.48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6071757" y="6267954"/>
            <a:ext cx="58174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inear model results:</a:t>
            </a:r>
          </a:p>
          <a:p>
            <a:r>
              <a:rPr lang="en-GB" sz="14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POE levels ~ N_APOE4 + N_APOE2 + OBCAM + Somascan_PC2</a:t>
            </a:r>
          </a:p>
          <a:p>
            <a:r>
              <a:rPr lang="en-GB" sz="14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djRsq</a:t>
            </a:r>
            <a:r>
              <a:rPr lang="en-GB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= 0.85</a:t>
            </a:r>
            <a:endParaRPr lang="en-GB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4" name="Tabla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4974337"/>
              </p:ext>
            </p:extLst>
          </p:nvPr>
        </p:nvGraphicFramePr>
        <p:xfrm>
          <a:off x="6071757" y="7207601"/>
          <a:ext cx="5548087" cy="18202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07347">
                  <a:extLst>
                    <a:ext uri="{9D8B030D-6E8A-4147-A177-3AD203B41FA5}">
                      <a16:colId xmlns:a16="http://schemas.microsoft.com/office/drawing/2014/main" val="1964598409"/>
                    </a:ext>
                  </a:extLst>
                </a:gridCol>
                <a:gridCol w="885185">
                  <a:extLst>
                    <a:ext uri="{9D8B030D-6E8A-4147-A177-3AD203B41FA5}">
                      <a16:colId xmlns:a16="http://schemas.microsoft.com/office/drawing/2014/main" val="3200499059"/>
                    </a:ext>
                  </a:extLst>
                </a:gridCol>
                <a:gridCol w="885185">
                  <a:extLst>
                    <a:ext uri="{9D8B030D-6E8A-4147-A177-3AD203B41FA5}">
                      <a16:colId xmlns:a16="http://schemas.microsoft.com/office/drawing/2014/main" val="3755377837"/>
                    </a:ext>
                  </a:extLst>
                </a:gridCol>
                <a:gridCol w="885185">
                  <a:extLst>
                    <a:ext uri="{9D8B030D-6E8A-4147-A177-3AD203B41FA5}">
                      <a16:colId xmlns:a16="http://schemas.microsoft.com/office/drawing/2014/main" val="2981736305"/>
                    </a:ext>
                  </a:extLst>
                </a:gridCol>
                <a:gridCol w="885185">
                  <a:extLst>
                    <a:ext uri="{9D8B030D-6E8A-4147-A177-3AD203B41FA5}">
                      <a16:colId xmlns:a16="http://schemas.microsoft.com/office/drawing/2014/main" val="428459201"/>
                    </a:ext>
                  </a:extLst>
                </a:gridCol>
              </a:tblGrid>
              <a:tr h="303381">
                <a:tc>
                  <a:txBody>
                    <a:bodyPr/>
                    <a:lstStyle/>
                    <a:p>
                      <a:pPr algn="l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Estimat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 err="1">
                          <a:effectLst/>
                        </a:rPr>
                        <a:t>Std</a:t>
                      </a:r>
                      <a:r>
                        <a:rPr lang="es-ES" sz="1200" b="1" u="none" strike="noStrike" dirty="0">
                          <a:effectLst/>
                        </a:rPr>
                        <a:t>. Error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t </a:t>
                      </a:r>
                      <a:r>
                        <a:rPr lang="es-ES" sz="1200" b="1" u="none" strike="noStrike" dirty="0" err="1">
                          <a:effectLst/>
                        </a:rPr>
                        <a:t>value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b="1" u="none" strike="noStrike" dirty="0">
                          <a:effectLst/>
                        </a:rPr>
                        <a:t>Pr(&gt;|t|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56209625"/>
                  </a:ext>
                </a:extLst>
              </a:tr>
              <a:tr h="30338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(</a:t>
                      </a:r>
                      <a:r>
                        <a:rPr lang="es-ES" sz="1200" b="1" u="none" strike="noStrike" dirty="0" err="1">
                          <a:effectLst/>
                        </a:rPr>
                        <a:t>Intercept</a:t>
                      </a:r>
                      <a:r>
                        <a:rPr lang="es-ES" sz="1200" b="1" u="none" strike="noStrike" dirty="0">
                          <a:effectLst/>
                        </a:rPr>
                        <a:t>)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78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81,97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0E+00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86486316"/>
                  </a:ext>
                </a:extLst>
              </a:tr>
              <a:tr h="30338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4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-0,59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45,57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7,68E-213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6912036"/>
                  </a:ext>
                </a:extLst>
              </a:tr>
              <a:tr h="30338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Number_APOE2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12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3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4,7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2,91E-06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57669976"/>
                  </a:ext>
                </a:extLst>
              </a:tr>
              <a:tr h="30338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OBCAM_seq.15622.13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25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0,0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34,12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>
                          <a:effectLst/>
                        </a:rPr>
                        <a:t>1,02E-151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11484348"/>
                  </a:ext>
                </a:extLst>
              </a:tr>
              <a:tr h="30338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u="none" strike="noStrike" dirty="0">
                          <a:effectLst/>
                        </a:rPr>
                        <a:t>Somalogic_PC.2</a:t>
                      </a:r>
                      <a:endParaRPr lang="es-E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0,05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0,00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-16,87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200" u="none" strike="noStrike" dirty="0">
                          <a:effectLst/>
                        </a:rPr>
                        <a:t>6,46E-54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61775440"/>
                  </a:ext>
                </a:extLst>
              </a:tr>
            </a:tbl>
          </a:graphicData>
        </a:graphic>
      </p:graphicFrame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3341145"/>
              </p:ext>
            </p:extLst>
          </p:nvPr>
        </p:nvGraphicFramePr>
        <p:xfrm>
          <a:off x="1211950" y="9868694"/>
          <a:ext cx="5537199" cy="1143000"/>
        </p:xfrm>
        <a:graphic>
          <a:graphicData uri="http://schemas.openxmlformats.org/drawingml/2006/table">
            <a:tbl>
              <a:tblPr/>
              <a:tblGrid>
                <a:gridCol w="2957404">
                  <a:extLst>
                    <a:ext uri="{9D8B030D-6E8A-4147-A177-3AD203B41FA5}">
                      <a16:colId xmlns:a16="http://schemas.microsoft.com/office/drawing/2014/main" val="1635902679"/>
                    </a:ext>
                  </a:extLst>
                </a:gridCol>
                <a:gridCol w="761563">
                  <a:extLst>
                    <a:ext uri="{9D8B030D-6E8A-4147-A177-3AD203B41FA5}">
                      <a16:colId xmlns:a16="http://schemas.microsoft.com/office/drawing/2014/main" val="4121889352"/>
                    </a:ext>
                  </a:extLst>
                </a:gridCol>
                <a:gridCol w="761563">
                  <a:extLst>
                    <a:ext uri="{9D8B030D-6E8A-4147-A177-3AD203B41FA5}">
                      <a16:colId xmlns:a16="http://schemas.microsoft.com/office/drawing/2014/main" val="4250069126"/>
                    </a:ext>
                  </a:extLst>
                </a:gridCol>
                <a:gridCol w="1056669">
                  <a:extLst>
                    <a:ext uri="{9D8B030D-6E8A-4147-A177-3AD203B41FA5}">
                      <a16:colId xmlns:a16="http://schemas.microsoft.com/office/drawing/2014/main" val="275281732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variates</a:t>
                      </a:r>
                      <a:r>
                        <a:rPr lang="es-E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cluded</a:t>
                      </a:r>
                      <a:endParaRPr lang="es-E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nAPO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E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E4/PanAPO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72189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,0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9490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 + PC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F1E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9F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,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4404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E4 + APOE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E8D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5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D7A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29303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 + PC2 + APOE4 + APOE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F7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F7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4640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CML + PC2 + APOE4 + APOE2 + age + se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F7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4888148"/>
                  </a:ext>
                </a:extLst>
              </a:tr>
            </a:tbl>
          </a:graphicData>
        </a:graphic>
      </p:graphicFrame>
      <p:sp>
        <p:nvSpPr>
          <p:cNvPr id="3" name="CuadroTexto 2"/>
          <p:cNvSpPr txBox="1"/>
          <p:nvPr/>
        </p:nvSpPr>
        <p:spPr>
          <a:xfrm>
            <a:off x="5184830" y="9591695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err="1" smtClean="0"/>
              <a:t>AdjRsq</a:t>
            </a:r>
            <a:endParaRPr lang="en-GB" sz="1200" b="1" dirty="0"/>
          </a:p>
        </p:txBody>
      </p:sp>
      <p:cxnSp>
        <p:nvCxnSpPr>
          <p:cNvPr id="15" name="Conector recto 14"/>
          <p:cNvCxnSpPr/>
          <p:nvPr/>
        </p:nvCxnSpPr>
        <p:spPr>
          <a:xfrm>
            <a:off x="4207195" y="9843294"/>
            <a:ext cx="25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550960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84</TotalTime>
  <Words>437</Words>
  <Application>Microsoft Office PowerPoint</Application>
  <PresentationFormat>Personalizado</PresentationFormat>
  <Paragraphs>152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gargon1@gmail.com</dc:creator>
  <cp:lastModifiedBy>pablogargon1@gmail.com</cp:lastModifiedBy>
  <cp:revision>282</cp:revision>
  <dcterms:created xsi:type="dcterms:W3CDTF">2025-11-02T16:36:45Z</dcterms:created>
  <dcterms:modified xsi:type="dcterms:W3CDTF">2026-04-14T10:00:02Z</dcterms:modified>
</cp:coreProperties>
</file>